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9947275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D92A70-4BD7-46A3-8643-97BC7825C1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236500-4072-4089-AA2C-4CA39C667A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BE4E2A-810B-403E-BC9D-3E685D896A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BB87F5-A825-4BB3-B15E-A4DD5638C2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9F4167-24A3-4042-937A-7B1FA0647C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012AA1-73E5-43F0-981F-951CDE81B9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41FA6-7771-487D-9119-C8FDF64E1F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D2EDE5-ED83-41F7-81ED-D6A6A102BF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3A2E19-5468-4DE2-A4C3-3205D4CB4F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F9B898-92C7-475E-9E21-4859814999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743A41-DEBB-4ED5-B84D-1598EEAD7B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665DB-35F2-44F7-9E53-51125949D8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E812EB-2473-41F6-89F8-3E70B2B85E91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13"/>
          <p:cNvGrpSpPr/>
          <p:nvPr/>
        </p:nvGrpSpPr>
        <p:grpSpPr>
          <a:xfrm>
            <a:off x="1165320" y="1643040"/>
            <a:ext cx="4351320" cy="2286000"/>
            <a:chOff x="1165320" y="1643040"/>
            <a:chExt cx="4351320" cy="2286000"/>
          </a:xfrm>
        </p:grpSpPr>
        <p:sp>
          <p:nvSpPr>
            <p:cNvPr id="42" name="Text Box 22"/>
            <p:cNvSpPr/>
            <p:nvPr/>
          </p:nvSpPr>
          <p:spPr>
            <a:xfrm>
              <a:off x="1812600" y="1643040"/>
              <a:ext cx="43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GFP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Text Box 23"/>
            <p:cNvSpPr/>
            <p:nvPr/>
          </p:nvSpPr>
          <p:spPr>
            <a:xfrm>
              <a:off x="3192120" y="1643040"/>
              <a:ext cx="57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CBP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Text Box 24"/>
            <p:cNvSpPr/>
            <p:nvPr/>
          </p:nvSpPr>
          <p:spPr>
            <a:xfrm>
              <a:off x="4424040" y="1643040"/>
              <a:ext cx="1038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PCBP1-p27 KD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pic>
          <p:nvPicPr>
            <p:cNvPr id="45" name="Picture 18" descr="A2780 GFP----1"/>
            <p:cNvPicPr/>
            <p:nvPr/>
          </p:nvPicPr>
          <p:blipFill>
            <a:blip r:embed="rId1"/>
            <a:stretch/>
          </p:blipFill>
          <p:spPr>
            <a:xfrm>
              <a:off x="1386000" y="1852560"/>
              <a:ext cx="1349280" cy="1015920"/>
            </a:xfrm>
            <a:prstGeom prst="rect">
              <a:avLst/>
            </a:prstGeom>
            <a:ln w="9360">
              <a:solidFill>
                <a:srgbClr val="0070c0"/>
              </a:solidFill>
              <a:miter/>
            </a:ln>
          </p:spPr>
        </p:pic>
        <p:pic>
          <p:nvPicPr>
            <p:cNvPr id="46" name="Picture 19" descr="A2780 PCBP1---3"/>
            <p:cNvPicPr/>
            <p:nvPr/>
          </p:nvPicPr>
          <p:blipFill>
            <a:blip r:embed="rId2"/>
            <a:stretch/>
          </p:blipFill>
          <p:spPr>
            <a:xfrm>
              <a:off x="2778120" y="1852560"/>
              <a:ext cx="1350720" cy="1014120"/>
            </a:xfrm>
            <a:prstGeom prst="rect">
              <a:avLst/>
            </a:prstGeom>
            <a:ln w="9360">
              <a:solidFill>
                <a:srgbClr val="0070c0"/>
              </a:solidFill>
              <a:miter/>
            </a:ln>
          </p:spPr>
        </p:pic>
        <p:pic>
          <p:nvPicPr>
            <p:cNvPr id="47" name="Picture 20" descr="A2780 PCBP1 p27 KD---1"/>
            <p:cNvPicPr/>
            <p:nvPr/>
          </p:nvPicPr>
          <p:blipFill>
            <a:blip r:embed="rId3"/>
            <a:stretch/>
          </p:blipFill>
          <p:spPr>
            <a:xfrm>
              <a:off x="4167360" y="1854000"/>
              <a:ext cx="1349280" cy="1015920"/>
            </a:xfrm>
            <a:prstGeom prst="rect">
              <a:avLst/>
            </a:prstGeom>
            <a:ln w="9360">
              <a:solidFill>
                <a:srgbClr val="0070c0"/>
              </a:solidFill>
              <a:miter/>
            </a:ln>
          </p:spPr>
        </p:pic>
        <p:pic>
          <p:nvPicPr>
            <p:cNvPr id="48" name="Picture 32" descr="DLD-1-GFP-24_1"/>
            <p:cNvPicPr/>
            <p:nvPr/>
          </p:nvPicPr>
          <p:blipFill>
            <a:blip r:embed="rId4"/>
            <a:stretch/>
          </p:blipFill>
          <p:spPr>
            <a:xfrm>
              <a:off x="1380960" y="2908080"/>
              <a:ext cx="1349280" cy="1015920"/>
            </a:xfrm>
            <a:prstGeom prst="rect">
              <a:avLst/>
            </a:prstGeom>
            <a:ln w="9360">
              <a:solidFill>
                <a:srgbClr val="0070c0"/>
              </a:solidFill>
              <a:miter/>
            </a:ln>
          </p:spPr>
        </p:pic>
        <p:pic>
          <p:nvPicPr>
            <p:cNvPr id="49" name="Picture 33" descr="DLD-1-GFP-PCBP1-24_1"/>
            <p:cNvPicPr/>
            <p:nvPr/>
          </p:nvPicPr>
          <p:blipFill>
            <a:blip r:embed="rId5"/>
            <a:stretch/>
          </p:blipFill>
          <p:spPr>
            <a:xfrm>
              <a:off x="2776680" y="2908080"/>
              <a:ext cx="1350720" cy="1015920"/>
            </a:xfrm>
            <a:prstGeom prst="rect">
              <a:avLst/>
            </a:prstGeom>
            <a:ln w="9360">
              <a:solidFill>
                <a:srgbClr val="0070c0"/>
              </a:solidFill>
              <a:miter/>
            </a:ln>
          </p:spPr>
        </p:pic>
        <p:pic>
          <p:nvPicPr>
            <p:cNvPr id="50" name="Picture 34" descr="DLD-1-PCBP1 p27 KD-24_3"/>
            <p:cNvPicPr/>
            <p:nvPr/>
          </p:nvPicPr>
          <p:blipFill>
            <a:blip r:embed="rId6"/>
            <a:stretch/>
          </p:blipFill>
          <p:spPr>
            <a:xfrm>
              <a:off x="4167360" y="2914920"/>
              <a:ext cx="1349280" cy="1014120"/>
            </a:xfrm>
            <a:prstGeom prst="rect">
              <a:avLst/>
            </a:prstGeom>
            <a:ln w="9360">
              <a:solidFill>
                <a:srgbClr val="0070c0"/>
              </a:solidFill>
              <a:miter/>
            </a:ln>
          </p:spPr>
        </p:pic>
        <p:sp>
          <p:nvSpPr>
            <p:cNvPr id="51" name="Text Box 40"/>
            <p:cNvSpPr/>
            <p:nvPr/>
          </p:nvSpPr>
          <p:spPr>
            <a:xfrm rot="16200000">
              <a:off x="1030320" y="2256840"/>
              <a:ext cx="528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A278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Text Box 41"/>
            <p:cNvSpPr/>
            <p:nvPr/>
          </p:nvSpPr>
          <p:spPr>
            <a:xfrm rot="16200000">
              <a:off x="1011240" y="3305880"/>
              <a:ext cx="55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DLD-1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3" name="Text Box 15"/>
          <p:cNvSpPr/>
          <p:nvPr/>
        </p:nvSpPr>
        <p:spPr>
          <a:xfrm>
            <a:off x="569880" y="4299120"/>
            <a:ext cx="59976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4. Colonies induced by A2780 or DLD-1 cells overexpressing PCBP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PCBP1, PCBP1-p27 KD and GFP control cells were analyzed by soft agar assay for anchorage-independent growth. Colonies were stained with Trypan Blue and photographed.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9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dc:description/>
  <dc:language>en-US</dc:language>
  <cp:lastModifiedBy>Hongshun</cp:lastModifiedBy>
  <dcterms:modified xsi:type="dcterms:W3CDTF">2018-06-25T03:14:15Z</dcterms:modified>
  <cp:revision>185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